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1F8F7-A7D0-45C3-8181-85775B51A7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ECB23-C420-44CB-977A-BD8FB475E1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C3F2F-224F-48A6-B8A2-48E62BED24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12120-B0DA-4CC0-837C-962C54F7A0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545F2-A7A7-425F-8DC0-CD823C6CCA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A3A93-4B00-429D-B3F6-00477CE315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2DB7F-D497-40D9-BA00-A0E88EBEF4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58248-0D4B-4838-A444-454BFD57FE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3F291-0744-47E3-9537-9F15688F68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430DD-2115-4B97-881A-DF985237DE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D790C-D1DC-4DD5-A80C-AF788559BA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55CC3-7098-4C78-A570-4E2334E3A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9A59CD-5350-412F-8047-51E1BD48E60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http://www.cbs.dtu.dk/services/SignalP-4.0/tmp/255264/Sequence.png"/>
          <p:cNvPicPr/>
          <p:nvPr/>
        </p:nvPicPr>
        <p:blipFill>
          <a:blip r:embed="rId1"/>
          <a:stretch/>
        </p:blipFill>
        <p:spPr>
          <a:xfrm>
            <a:off x="1979640" y="1014480"/>
            <a:ext cx="5616720" cy="42148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185640" y="549360"/>
            <a:ext cx="346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pag11a signal peptide predi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197440" y="5229360"/>
            <a:ext cx="472068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Measure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Position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Value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Cutoff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signal peptide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max. C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20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858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max. Y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20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86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max. S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8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94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mean S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1-19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85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D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1-19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860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0.450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Y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Name=Sequence SP='YES'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Cleavage site between pos. 19 and 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NSG-DI D=0.860 D-cutoff=0.450 Networks=SignalP-noT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2440" y="93600"/>
            <a:ext cx="243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ditional file 4: Figure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01T10:02:44Z</dcterms:created>
  <dc:creator>Ari Pujianto</dc:creator>
  <dc:description/>
  <dc:language>en-US</dc:language>
  <cp:lastModifiedBy>Ari Pujianto</cp:lastModifiedBy>
  <dcterms:modified xsi:type="dcterms:W3CDTF">2013-06-29T13:28:44Z</dcterms:modified>
  <cp:revision>7</cp:revision>
  <dc:subject/>
  <dc:title>Slide 1</dc:title>
</cp:coreProperties>
</file>